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078A2B7-1EA9-1956-A216-6874EE781DF3}" name="Roberto Moretto" initials="RM" userId="Roberto Moretto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4" d="100"/>
          <a:sy n="54" d="100"/>
        </p:scale>
        <p:origin x="48" y="4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2D0C7D-0C19-0679-EFDC-A179882588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9A6B90D-4031-DB0D-B6B0-E75FED73BE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13AD6BA-D1ED-3DD9-FD7E-388617BA5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6A0BB5-B6FF-4AD3-B6F3-A52B1352D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3B3D8C2-AD79-CC07-A777-B52D733CF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9116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DCF592-9D5F-5AD3-39C4-8A0BEE1A79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08D0367-995B-E0F5-E629-A9CDA5A60C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FBE755-FD99-7018-D4EA-F72ED741C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D4EAED-2F5A-9EBA-3425-5B5289DB3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74A7820-4CE6-7F6F-F85C-E4617255D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0854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5C1687A-4D40-C02A-26F5-24ACD6FCCA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983C277-D1C3-EC67-E76E-87118345D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70BD13-C915-A024-5C38-044FDB1F2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C91EDAD-3CE4-8101-D7B6-069A8EBE6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AD6ACB8-2F8B-5B95-727B-EAB234E88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136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990C685-CD1D-368A-A965-A0BA4E454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156DD5F-6569-8B26-D8FA-F734F9FE0E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E26F8F-DDE7-2C1B-11D7-A231617AF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5F31C5-7E14-0530-A787-42D45F580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D773FD-1575-D72D-DB1E-D44FDAD13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1919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4684F1-2FDC-B7CB-A4DB-03132F03F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023843C-EFE1-9E02-7027-CFEEC87289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C9810E1-1211-970C-87EE-A644F391D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AF51E47-6006-6E19-E712-11B5D1ED3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688EE47-ADC4-C056-9BFE-26D00F177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4524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36EC7C-D805-F0D0-9182-635CCDB88B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B872817-B87B-D1D3-5FD5-FF8C432363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5629765-90AC-D232-403C-9D90FC9F90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72B0FE7-2EE6-3840-E2D0-3EFA35910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50AFD24-E891-7D15-0494-3CFB51D8B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FC60360-AC49-D28F-F084-4237E13AA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3554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B84C38-A51A-94FF-7AFF-41D74A9184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721192B-B8A6-C997-EF06-D9DC57DEEE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9615D69-85B2-B41B-BE23-28EC30E942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08B438A-A805-0855-6DBB-AE9944C4CD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F7225A6-78BC-4D27-390C-AEA8D1CAF1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ACD012C-0669-9465-64C0-440FF29EB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97DCBA6-F049-ADD9-1AB5-B58908822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EFC9F0D-AE7F-5CAD-5200-4D7D9A11E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5322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B59D2F6-36F3-6994-9C42-EF5352C588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A7B9B7B-A225-9F14-81D5-5F0B5F796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1647EAF-4E27-A030-6B5E-56C6005CF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A29409F-56E4-49B2-4052-4B43A778E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9069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F9AE950-3EA7-3993-90F5-84EEBA008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604EE3F-3372-2C34-CC52-D8B6883BF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8136584-C294-43BC-8BE4-4F859EE0F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5913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66DDF83-2A17-3E5A-94A4-4D52D9609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C809677-3130-8A01-B6EF-5D2734ED9F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7F87068-122E-FF67-F4F8-062F6CCD90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4597A05-A963-2105-2C62-7DF1910BF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3F4989D-D875-ED42-FCEA-077185057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49C9DC1-7BB9-248F-4A36-1F222FC99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8234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B418D1-ED18-04F6-D1C7-3DDD5B3B4E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BF62A18-50BA-030D-620A-0782A174F8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3D51847-511F-BA33-8B24-CD9C518F35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1746C1F-9D9D-2C11-FDCD-9F867F97A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5334CBA-51F8-5DDB-E30C-A6ABFB768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AAB482D-4CB5-D557-437A-D5426B96E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2387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8A46FC6-01B6-307B-B142-A6623B1BD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9C2A3F5-6266-0125-400F-B34A93DCAD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0569C8-0CF7-D534-D1DB-99BE2EE22E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3976E-D779-4E02-B6D0-DFE7064E10F1}" type="datetimeFigureOut">
              <a:rPr lang="it-IT" smtClean="0"/>
              <a:t>09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E6C47FF-EC0E-CE08-C90A-97C41399E1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3DEA8D3-61D8-3131-09C4-A3466B58C0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5AF48D-0B26-4578-AD82-B86EC616F0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534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E1311296-D647-2C9A-6F4D-9225DA315A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9218" y="1433251"/>
            <a:ext cx="5724525" cy="4295775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C2E13E5C-4E82-0C8D-3D66-FE12E00581A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/>
          <a:stretch/>
        </p:blipFill>
        <p:spPr>
          <a:xfrm>
            <a:off x="371476" y="1433251"/>
            <a:ext cx="5601308" cy="4295775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B04CAAC-36B2-CBB5-5D2B-217296712BAB}"/>
              </a:ext>
            </a:extLst>
          </p:cNvPr>
          <p:cNvSpPr txBox="1"/>
          <p:nvPr/>
        </p:nvSpPr>
        <p:spPr>
          <a:xfrm>
            <a:off x="371476" y="158560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0347D80-BC41-40DE-C768-FB91C171C019}"/>
              </a:ext>
            </a:extLst>
          </p:cNvPr>
          <p:cNvSpPr txBox="1"/>
          <p:nvPr/>
        </p:nvSpPr>
        <p:spPr>
          <a:xfrm>
            <a:off x="6057154" y="158560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5DE2976B-429B-E666-FEBA-108C17475520}"/>
              </a:ext>
            </a:extLst>
          </p:cNvPr>
          <p:cNvSpPr txBox="1"/>
          <p:nvPr/>
        </p:nvSpPr>
        <p:spPr>
          <a:xfrm>
            <a:off x="3944849" y="1770275"/>
            <a:ext cx="18179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/>
              <a:t>Median</a:t>
            </a:r>
            <a:r>
              <a:rPr lang="it-IT" sz="1100" b="1" dirty="0"/>
              <a:t> DFS: 9.7 months </a:t>
            </a:r>
          </a:p>
          <a:p>
            <a:r>
              <a:rPr lang="it-IT" sz="1100" b="1" dirty="0"/>
              <a:t>95% CI: 8.06-11.5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6DEC2CF-666C-D495-27C5-ABC5ABABB5C8}"/>
              </a:ext>
            </a:extLst>
          </p:cNvPr>
          <p:cNvSpPr txBox="1"/>
          <p:nvPr/>
        </p:nvSpPr>
        <p:spPr>
          <a:xfrm>
            <a:off x="10069033" y="1770275"/>
            <a:ext cx="175149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err="1"/>
              <a:t>Median</a:t>
            </a:r>
            <a:r>
              <a:rPr lang="it-IT" sz="1100" b="1" dirty="0"/>
              <a:t> OS: 49.7 months </a:t>
            </a:r>
          </a:p>
          <a:p>
            <a:r>
              <a:rPr lang="it-IT" sz="1100" b="1" dirty="0"/>
              <a:t>95% CI: 40.49-64.57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46C15778-68BC-EF9E-5530-1EEA4E3C6249}"/>
              </a:ext>
            </a:extLst>
          </p:cNvPr>
          <p:cNvSpPr txBox="1"/>
          <p:nvPr/>
        </p:nvSpPr>
        <p:spPr>
          <a:xfrm rot="16200000">
            <a:off x="-978740" y="3248720"/>
            <a:ext cx="296204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/>
              <a:t>Disease</a:t>
            </a:r>
            <a:r>
              <a:rPr lang="it-IT" sz="1100" dirty="0"/>
              <a:t>-free survival </a:t>
            </a:r>
            <a:r>
              <a:rPr lang="it-IT" sz="1100" dirty="0" err="1"/>
              <a:t>probability</a:t>
            </a:r>
            <a:r>
              <a:rPr lang="it-IT" sz="1100" dirty="0"/>
              <a:t> (%)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6AE92AED-4139-EC7C-1E0E-00D5ECA5AE90}"/>
              </a:ext>
            </a:extLst>
          </p:cNvPr>
          <p:cNvSpPr txBox="1"/>
          <p:nvPr/>
        </p:nvSpPr>
        <p:spPr>
          <a:xfrm rot="16200000">
            <a:off x="4769456" y="3245860"/>
            <a:ext cx="296204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100" dirty="0"/>
              <a:t>Overall survival </a:t>
            </a:r>
            <a:r>
              <a:rPr lang="it-IT" sz="1100" dirty="0" err="1"/>
              <a:t>probability</a:t>
            </a:r>
            <a:r>
              <a:rPr lang="it-IT" sz="1100" dirty="0"/>
              <a:t> (%)</a:t>
            </a:r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F9413B62-BC94-B611-1FD3-2C87AEDA74E5}"/>
              </a:ext>
            </a:extLst>
          </p:cNvPr>
          <p:cNvSpPr/>
          <p:nvPr/>
        </p:nvSpPr>
        <p:spPr>
          <a:xfrm>
            <a:off x="2089178" y="1515089"/>
            <a:ext cx="3304625" cy="1516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99B0D44A-385C-4A9D-265F-8BBAA405B241}"/>
              </a:ext>
            </a:extLst>
          </p:cNvPr>
          <p:cNvSpPr txBox="1"/>
          <p:nvPr/>
        </p:nvSpPr>
        <p:spPr>
          <a:xfrm>
            <a:off x="1141580" y="220493"/>
            <a:ext cx="102177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Disease Free Survival (A) and Overall Survival (B) after resection of CRLMs</a:t>
            </a:r>
            <a:endParaRPr lang="it-IT" sz="16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28EBA48-AC54-7537-8FCE-9CDAC36926DF}"/>
              </a:ext>
            </a:extLst>
          </p:cNvPr>
          <p:cNvSpPr txBox="1"/>
          <p:nvPr/>
        </p:nvSpPr>
        <p:spPr>
          <a:xfrm>
            <a:off x="502280" y="6105236"/>
            <a:ext cx="1179639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gend:</a:t>
            </a:r>
          </a:p>
          <a:p>
            <a:pPr algn="just"/>
            <a:r>
              <a:rPr lang="en-GB" sz="14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I: confidence interval; CLRMs: Colorectal Liver Metastases; DFS: Disease Free Survival; OS: Overall Survival</a:t>
            </a:r>
            <a:endParaRPr lang="it-IT" sz="12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44046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73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Marco Maria Germani</cp:lastModifiedBy>
  <cp:revision>10</cp:revision>
  <dcterms:created xsi:type="dcterms:W3CDTF">2023-10-10T11:11:53Z</dcterms:created>
  <dcterms:modified xsi:type="dcterms:W3CDTF">2024-03-09T14:59:25Z</dcterms:modified>
</cp:coreProperties>
</file>